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567"/>
  </p:normalViewPr>
  <p:slideViewPr>
    <p:cSldViewPr snapToGrid="0" snapToObjects="1">
      <p:cViewPr>
        <p:scale>
          <a:sx n="91" d="100"/>
          <a:sy n="91" d="100"/>
        </p:scale>
        <p:origin x="2024" y="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6C5C6-19CC-3746-B7A0-74A1AC1AF384}" type="datetimeFigureOut">
              <a:rPr lang="en-US" smtClean="0"/>
              <a:t>3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325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4256328"/>
            <a:ext cx="9906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ry Figure 3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Using PRNT assay to determine the neutralising capability of sera from ZIKV-infected animals.</a:t>
            </a:r>
            <a:r>
              <a:rPr lang="en-GB" sz="12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ZIKV prepared to 120 PFU per reaction was pre-incubated with 5-fold serial dilutions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5 dpi ZIKV-specific IgG prior to infecting 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VeroE6 cells. Mock-infected and ZIKV only conditions were used as controls. Plaque numbers were quantified 4 days after incubation. Data are normalised to ZIKV only control and represent an average of two independent experiments. </a:t>
            </a:r>
            <a:r>
              <a:rPr lang="en-SG" sz="1200" b="1" dirty="0">
                <a:latin typeface="Arial" panose="020B0604020202020204" pitchFamily="34" charset="0"/>
                <a:cs typeface="Arial" panose="020B0604020202020204" pitchFamily="34" charset="0"/>
              </a:rPr>
              <a:t>(b-c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Neutralising capability of pooled mouse sera from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ype I IFN competent or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AR1-5A3-treated WT animals upon depletion of ZIKV-specific antibodies targeting peptides that are either common epitope: P4, Type I IFN competent dominant epitopes: P5, P6 or P21, or MAR1-5A3-treated dominant epitopes: P8 or P13. A non-specific peptide control, OVA, was also included. ZIKV prepared to 120 PFU per reaction was pre-incubated with 0.5 µg/ml of ZIKV-specific IgG. 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Plaque numbers were quantified 4 days after incubation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sults are expressed as log</a:t>
            </a:r>
            <a:r>
              <a:rPr lang="en-GB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old change relative to the respective non-depleted controls.</a:t>
            </a:r>
            <a:endParaRPr lang="en-SG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478732" y="6606794"/>
            <a:ext cx="24272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. Figure 3_Lee et al., 2020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EF98623-FFA8-4349-BAD8-5781A3E964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6674"/>
            <a:ext cx="3336651" cy="236522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10BA2F7-A623-9748-B7FF-87273497D1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93537" y="1686674"/>
            <a:ext cx="3175812" cy="234909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977A074-7174-2D45-88D2-2D96BEE42E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26235" y="1691915"/>
            <a:ext cx="3078192" cy="23438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D7D2D83-C8BE-BF4C-A285-F590F76105DA}"/>
              </a:ext>
            </a:extLst>
          </p:cNvPr>
          <p:cNvSpPr txBox="1"/>
          <p:nvPr/>
        </p:nvSpPr>
        <p:spPr>
          <a:xfrm>
            <a:off x="0" y="1317342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9A85BA7-F4FD-7944-9C26-85171490B404}"/>
              </a:ext>
            </a:extLst>
          </p:cNvPr>
          <p:cNvSpPr txBox="1"/>
          <p:nvPr/>
        </p:nvSpPr>
        <p:spPr>
          <a:xfrm>
            <a:off x="3217819" y="1317342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5E63FC0-39F3-D74C-BB69-D6EE40311742}"/>
              </a:ext>
            </a:extLst>
          </p:cNvPr>
          <p:cNvSpPr txBox="1"/>
          <p:nvPr/>
        </p:nvSpPr>
        <p:spPr>
          <a:xfrm>
            <a:off x="6507909" y="132041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1859491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212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RYL</dc:creator>
  <cp:lastModifiedBy>Cheryl Lee Yi Pin</cp:lastModifiedBy>
  <cp:revision>22</cp:revision>
  <dcterms:created xsi:type="dcterms:W3CDTF">2019-02-07T06:14:48Z</dcterms:created>
  <dcterms:modified xsi:type="dcterms:W3CDTF">2020-03-16T07:54:57Z</dcterms:modified>
</cp:coreProperties>
</file>